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6" r:id="rId3"/>
    <p:sldId id="257" r:id="rId4"/>
    <p:sldId id="258" r:id="rId5"/>
    <p:sldId id="259" r:id="rId6"/>
    <p:sldId id="260" r:id="rId7"/>
  </p:sldIdLst>
  <p:sldSz cx="9144000" cy="6858000" type="screen4x3"/>
  <p:notesSz cx="7099300" cy="10234613"/>
  <p:custDataLst>
    <p:tags r:id="rId8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3" d="100"/>
          <a:sy n="123" d="100"/>
        </p:scale>
        <p:origin x="-1200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A11EF-A067-4F6F-833F-54982EABBA18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293EA-FC1D-4B31-BFC6-7B22F3161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59203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A11EF-A067-4F6F-833F-54982EABBA18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293EA-FC1D-4B31-BFC6-7B22F3161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914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A11EF-A067-4F6F-833F-54982EABBA18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293EA-FC1D-4B31-BFC6-7B22F3161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7114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A11EF-A067-4F6F-833F-54982EABBA18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293EA-FC1D-4B31-BFC6-7B22F3161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697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A11EF-A067-4F6F-833F-54982EABBA18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293EA-FC1D-4B31-BFC6-7B22F3161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6375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A11EF-A067-4F6F-833F-54982EABBA18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293EA-FC1D-4B31-BFC6-7B22F3161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134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A11EF-A067-4F6F-833F-54982EABBA18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293EA-FC1D-4B31-BFC6-7B22F3161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8687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A11EF-A067-4F6F-833F-54982EABBA18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293EA-FC1D-4B31-BFC6-7B22F3161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02439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A11EF-A067-4F6F-833F-54982EABBA18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293EA-FC1D-4B31-BFC6-7B22F3161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26580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A11EF-A067-4F6F-833F-54982EABBA18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293EA-FC1D-4B31-BFC6-7B22F3161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8036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A11EF-A067-4F6F-833F-54982EABBA18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293EA-FC1D-4B31-BFC6-7B22F3161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6602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BA11EF-A067-4F6F-833F-54982EABBA18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8293EA-FC1D-4B31-BFC6-7B22F3161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8960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ontent Placeholder 4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de-CH" sz="2000" b="1" dirty="0" err="1" smtClean="0"/>
              <a:t>Supplementary</a:t>
            </a:r>
            <a:r>
              <a:rPr lang="de-CH" sz="2000" b="1" dirty="0" smtClean="0"/>
              <a:t> Fig. 3:</a:t>
            </a:r>
            <a:r>
              <a:rPr lang="de-CH" sz="2000" dirty="0" smtClean="0"/>
              <a:t> </a:t>
            </a:r>
            <a:r>
              <a:rPr lang="de-CH" sz="2000" b="1" dirty="0" err="1" smtClean="0"/>
              <a:t>summary</a:t>
            </a:r>
            <a:r>
              <a:rPr lang="de-CH" sz="2000" b="1" dirty="0" smtClean="0"/>
              <a:t> </a:t>
            </a:r>
            <a:r>
              <a:rPr lang="de-CH" sz="2000" b="1" dirty="0" err="1" smtClean="0"/>
              <a:t>of</a:t>
            </a:r>
            <a:r>
              <a:rPr lang="de-CH" sz="2000" b="1" dirty="0" smtClean="0"/>
              <a:t> </a:t>
            </a:r>
            <a:r>
              <a:rPr lang="de-CH" sz="2000" b="1" dirty="0" err="1" smtClean="0"/>
              <a:t>the</a:t>
            </a:r>
            <a:r>
              <a:rPr lang="de-CH" sz="2000" b="1" dirty="0" smtClean="0"/>
              <a:t> </a:t>
            </a:r>
            <a:r>
              <a:rPr lang="de-CH" sz="2000" b="1" dirty="0" err="1" smtClean="0"/>
              <a:t>calibration</a:t>
            </a:r>
            <a:r>
              <a:rPr lang="de-CH" sz="2000" b="1" dirty="0" smtClean="0"/>
              <a:t> </a:t>
            </a:r>
            <a:r>
              <a:rPr lang="de-CH" sz="2000" b="1" dirty="0" err="1" smtClean="0"/>
              <a:t>curves</a:t>
            </a:r>
            <a:r>
              <a:rPr lang="de-CH" sz="2000" b="1" dirty="0" smtClean="0"/>
              <a:t>.</a:t>
            </a:r>
            <a:r>
              <a:rPr lang="de-CH" sz="2000" dirty="0" smtClean="0"/>
              <a:t> </a:t>
            </a:r>
            <a:r>
              <a:rPr lang="en-US" sz="2000" dirty="0" smtClean="0"/>
              <a:t>Calibration </a:t>
            </a:r>
            <a:r>
              <a:rPr lang="en-US" sz="2000" dirty="0"/>
              <a:t>curves were generated for unique peptides belonging to OAT, DPYL2, PADI3, GM2A, and CLIC3 proteins. Values highlighted in yellow represent </a:t>
            </a:r>
            <a:r>
              <a:rPr lang="en-US" sz="2000" dirty="0" smtClean="0"/>
              <a:t>limit of detection (LOD) while those </a:t>
            </a:r>
            <a:r>
              <a:rPr lang="en-US" sz="2000" dirty="0"/>
              <a:t>highlighted in red represent </a:t>
            </a:r>
            <a:r>
              <a:rPr lang="en-US" sz="2000" dirty="0" smtClean="0"/>
              <a:t>Lower Limit of Quantitation (LLOQ). </a:t>
            </a:r>
            <a:r>
              <a:rPr lang="en-US" sz="2000" dirty="0"/>
              <a:t>"ND" indicates that no </a:t>
            </a:r>
            <a:r>
              <a:rPr lang="en-US" sz="2000" dirty="0" err="1"/>
              <a:t>analyte</a:t>
            </a:r>
            <a:r>
              <a:rPr lang="en-US" sz="2000" dirty="0"/>
              <a:t> was detected. </a:t>
            </a:r>
            <a:r>
              <a:rPr lang="en-US" sz="2000" dirty="0" smtClean="0"/>
              <a:t>Measurements taken </a:t>
            </a:r>
            <a:r>
              <a:rPr lang="en-US" sz="2000" dirty="0"/>
              <a:t>at lower concentrations on the calibration curve may show variability due to background interference.</a:t>
            </a:r>
          </a:p>
        </p:txBody>
      </p:sp>
    </p:spTree>
    <p:extLst>
      <p:ext uri="{BB962C8B-B14F-4D97-AF65-F5344CB8AC3E}">
        <p14:creationId xmlns:p14="http://schemas.microsoft.com/office/powerpoint/2010/main" val="37418025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742272"/>
            <a:ext cx="8573889" cy="18946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228" y="2636911"/>
            <a:ext cx="8602693" cy="38212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4539566" y="1622319"/>
            <a:ext cx="1095172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CH" sz="1100" dirty="0" smtClean="0"/>
              <a:t>LOD: 100 </a:t>
            </a:r>
            <a:r>
              <a:rPr lang="de-CH" sz="1100" dirty="0" err="1" smtClean="0"/>
              <a:t>amol</a:t>
            </a:r>
            <a:endParaRPr lang="de-CH" sz="1100" dirty="0" smtClean="0"/>
          </a:p>
          <a:p>
            <a:r>
              <a:rPr lang="de-CH" sz="1100" dirty="0" smtClean="0"/>
              <a:t>LLOQ: 150 </a:t>
            </a:r>
            <a:r>
              <a:rPr lang="de-CH" sz="1100" dirty="0" err="1" smtClean="0"/>
              <a:t>amol</a:t>
            </a:r>
            <a:endParaRPr lang="en-US" sz="1100" dirty="0"/>
          </a:p>
        </p:txBody>
      </p:sp>
      <p:sp>
        <p:nvSpPr>
          <p:cNvPr id="13" name="TextBox 12"/>
          <p:cNvSpPr txBox="1"/>
          <p:nvPr/>
        </p:nvSpPr>
        <p:spPr>
          <a:xfrm>
            <a:off x="4539566" y="3515029"/>
            <a:ext cx="1023037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CH" sz="1100" dirty="0" smtClean="0"/>
              <a:t>LOD: 50 </a:t>
            </a:r>
            <a:r>
              <a:rPr lang="de-CH" sz="1100" dirty="0" err="1" smtClean="0"/>
              <a:t>amol</a:t>
            </a:r>
            <a:endParaRPr lang="de-CH" sz="1100" dirty="0" smtClean="0"/>
          </a:p>
          <a:p>
            <a:r>
              <a:rPr lang="de-CH" sz="1100" dirty="0" smtClean="0"/>
              <a:t>LLOQ: 75 </a:t>
            </a:r>
            <a:r>
              <a:rPr lang="de-CH" sz="1100" dirty="0" err="1" smtClean="0"/>
              <a:t>amol</a:t>
            </a:r>
            <a:endParaRPr lang="en-US" sz="1100" dirty="0"/>
          </a:p>
        </p:txBody>
      </p:sp>
      <p:sp>
        <p:nvSpPr>
          <p:cNvPr id="14" name="TextBox 13"/>
          <p:cNvSpPr txBox="1"/>
          <p:nvPr/>
        </p:nvSpPr>
        <p:spPr>
          <a:xfrm>
            <a:off x="4539566" y="5476563"/>
            <a:ext cx="1095172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CH" sz="1100" dirty="0" smtClean="0"/>
              <a:t>LOD: 100 </a:t>
            </a:r>
            <a:r>
              <a:rPr lang="de-CH" sz="1100" dirty="0" err="1" smtClean="0"/>
              <a:t>amol</a:t>
            </a:r>
            <a:endParaRPr lang="de-CH" sz="1100" dirty="0" smtClean="0"/>
          </a:p>
          <a:p>
            <a:r>
              <a:rPr lang="de-CH" sz="1100" dirty="0" smtClean="0"/>
              <a:t>LLOQ: 150 </a:t>
            </a:r>
            <a:r>
              <a:rPr lang="de-CH" sz="1100" dirty="0" err="1" smtClean="0"/>
              <a:t>amol</a:t>
            </a:r>
            <a:endParaRPr lang="en-US" sz="1100" dirty="0"/>
          </a:p>
        </p:txBody>
      </p:sp>
      <p:sp>
        <p:nvSpPr>
          <p:cNvPr id="5" name="TextBox 4"/>
          <p:cNvSpPr txBox="1"/>
          <p:nvPr/>
        </p:nvSpPr>
        <p:spPr>
          <a:xfrm>
            <a:off x="395536" y="302031"/>
            <a:ext cx="61632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2000" b="1" dirty="0" smtClean="0"/>
              <a:t>OAT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11610971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696" y="668022"/>
            <a:ext cx="8573889" cy="3840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939" y="4608353"/>
            <a:ext cx="8787814" cy="19825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4554314" y="1519083"/>
            <a:ext cx="1095172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CH" sz="1100" dirty="0" smtClean="0"/>
              <a:t>LOD: 100 </a:t>
            </a:r>
            <a:r>
              <a:rPr lang="de-CH" sz="1100" dirty="0" err="1" smtClean="0"/>
              <a:t>amol</a:t>
            </a:r>
            <a:endParaRPr lang="de-CH" sz="1100" dirty="0" smtClean="0"/>
          </a:p>
          <a:p>
            <a:r>
              <a:rPr lang="de-CH" sz="1100" dirty="0" smtClean="0"/>
              <a:t>LLOQ: 150 </a:t>
            </a:r>
            <a:r>
              <a:rPr lang="de-CH" sz="1100" dirty="0" err="1" smtClean="0"/>
              <a:t>amol</a:t>
            </a:r>
            <a:endParaRPr lang="en-US" sz="1100" dirty="0"/>
          </a:p>
        </p:txBody>
      </p:sp>
      <p:sp>
        <p:nvSpPr>
          <p:cNvPr id="6" name="TextBox 5"/>
          <p:cNvSpPr txBox="1"/>
          <p:nvPr/>
        </p:nvSpPr>
        <p:spPr>
          <a:xfrm>
            <a:off x="4554314" y="5546394"/>
            <a:ext cx="1095172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CH" sz="1100" dirty="0" smtClean="0"/>
              <a:t>LOD: 100 </a:t>
            </a:r>
            <a:r>
              <a:rPr lang="de-CH" sz="1100" dirty="0" err="1" smtClean="0"/>
              <a:t>amol</a:t>
            </a:r>
            <a:endParaRPr lang="de-CH" sz="1100" dirty="0" smtClean="0"/>
          </a:p>
          <a:p>
            <a:r>
              <a:rPr lang="de-CH" sz="1100" dirty="0" smtClean="0"/>
              <a:t>LLOQ: 150 </a:t>
            </a:r>
            <a:r>
              <a:rPr lang="de-CH" sz="1100" dirty="0" err="1" smtClean="0"/>
              <a:t>amol</a:t>
            </a:r>
            <a:endParaRPr lang="en-US" sz="1100" dirty="0"/>
          </a:p>
        </p:txBody>
      </p:sp>
      <p:sp>
        <p:nvSpPr>
          <p:cNvPr id="7" name="TextBox 6"/>
          <p:cNvSpPr txBox="1"/>
          <p:nvPr/>
        </p:nvSpPr>
        <p:spPr>
          <a:xfrm>
            <a:off x="4554314" y="3556363"/>
            <a:ext cx="1095172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CH" sz="1100" dirty="0" smtClean="0"/>
              <a:t>LOD: 150 </a:t>
            </a:r>
            <a:r>
              <a:rPr lang="de-CH" sz="1100" dirty="0" err="1" smtClean="0"/>
              <a:t>amol</a:t>
            </a:r>
            <a:endParaRPr lang="de-CH" sz="1100" dirty="0" smtClean="0"/>
          </a:p>
          <a:p>
            <a:r>
              <a:rPr lang="de-CH" sz="1100" dirty="0" smtClean="0"/>
              <a:t>LLOQ: 200 </a:t>
            </a:r>
            <a:r>
              <a:rPr lang="de-CH" sz="1100" dirty="0" err="1" smtClean="0"/>
              <a:t>amol</a:t>
            </a:r>
            <a:endParaRPr lang="en-US" sz="1100" dirty="0"/>
          </a:p>
        </p:txBody>
      </p:sp>
      <p:sp>
        <p:nvSpPr>
          <p:cNvPr id="8" name="TextBox 7"/>
          <p:cNvSpPr txBox="1"/>
          <p:nvPr/>
        </p:nvSpPr>
        <p:spPr>
          <a:xfrm>
            <a:off x="395536" y="302031"/>
            <a:ext cx="8531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2000" b="1" dirty="0" smtClean="0"/>
              <a:t>DPYL2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40728885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0224" y="4756176"/>
            <a:ext cx="8431151" cy="18608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0224" y="779204"/>
            <a:ext cx="8437917" cy="38332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390224" y="302031"/>
            <a:ext cx="81971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2000" b="1" dirty="0" smtClean="0"/>
              <a:t>PADI3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34909745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0716" y="765175"/>
            <a:ext cx="8776246" cy="39415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324" y="4835730"/>
            <a:ext cx="8739030" cy="19115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50716" y="302031"/>
            <a:ext cx="8579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2000" b="1" dirty="0" smtClean="0"/>
              <a:t>GM2A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7074778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0722" y="742950"/>
            <a:ext cx="8739030" cy="3975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250722" y="302031"/>
            <a:ext cx="7649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2000" b="1" dirty="0" smtClean="0"/>
              <a:t>CLIC3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11900563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ARPPTCOMPATIBLE4" val="RXP"/>
  <p:tag name="VARPPTCOMPATIBLERD03" val="RXP"/>
  <p:tag name="VARPPTTYPE" val="RXP"/>
  <p:tag name="VARPPTSLIDEFORMAT" val="RXP"/>
  <p:tag name="VARSAVEMESSAGETIMESTAMP" val="RXP22-Jan-18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6</Words>
  <Application>Microsoft Office PowerPoint</Application>
  <PresentationFormat>On-screen Show (4:3)</PresentationFormat>
  <Paragraphs>18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F. Hoffmann-La Roche, Ltd.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ucret, Axel {PNBP~Basel}</dc:creator>
  <cp:lastModifiedBy>Ducret, Axel {PNBP~Basel}</cp:lastModifiedBy>
  <cp:revision>9</cp:revision>
  <cp:lastPrinted>2018-01-22T17:18:26Z</cp:lastPrinted>
  <dcterms:created xsi:type="dcterms:W3CDTF">2018-01-22T14:01:08Z</dcterms:created>
  <dcterms:modified xsi:type="dcterms:W3CDTF">2018-12-13T12:16:45Z</dcterms:modified>
</cp:coreProperties>
</file>